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notesMasterIdLst>
    <p:notesMasterId r:id="rId9"/>
  </p:notesMasterIdLst>
  <p:sldIdLst>
    <p:sldId id="274" r:id="rId2"/>
    <p:sldId id="276" r:id="rId3"/>
    <p:sldId id="275" r:id="rId4"/>
    <p:sldId id="257" r:id="rId5"/>
    <p:sldId id="279" r:id="rId6"/>
    <p:sldId id="284" r:id="rId7"/>
    <p:sldId id="285" r:id="rId8"/>
  </p:sldIdLst>
  <p:sldSz cx="6858000" cy="9144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380"/>
    <p:restoredTop sz="94660"/>
  </p:normalViewPr>
  <p:slideViewPr>
    <p:cSldViewPr>
      <p:cViewPr>
        <p:scale>
          <a:sx n="83" d="100"/>
          <a:sy n="83" d="100"/>
        </p:scale>
        <p:origin x="-3120" y="-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4" Type="http://schemas.openxmlformats.org/officeDocument/2006/relationships/image" Target="../media/image7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image" Target="../media/image14.emf"/><Relationship Id="rId5" Type="http://schemas.openxmlformats.org/officeDocument/2006/relationships/image" Target="../media/image18.emf"/><Relationship Id="rId4" Type="http://schemas.openxmlformats.org/officeDocument/2006/relationships/image" Target="../media/image17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emf"/><Relationship Id="rId1" Type="http://schemas.openxmlformats.org/officeDocument/2006/relationships/image" Target="../media/image19.emf"/><Relationship Id="rId5" Type="http://schemas.openxmlformats.org/officeDocument/2006/relationships/image" Target="../media/image23.emf"/><Relationship Id="rId4" Type="http://schemas.openxmlformats.org/officeDocument/2006/relationships/image" Target="../media/image2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עליונה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7B4B32BB-336F-41AD-836D-7FDAF84894BC}" type="datetimeFigureOut">
              <a:rPr lang="he-IL" smtClean="0"/>
              <a:t>ב'/אדר ב/תשפ"ב</a:t>
            </a:fld>
            <a:endParaRPr lang="he-IL"/>
          </a:p>
        </p:txBody>
      </p:sp>
      <p:sp>
        <p:nvSpPr>
          <p:cNvPr id="4" name="מציין מיקום של תמונת שקופית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מציין מיקום של הערות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05E2F36D-721B-4A5A-A68A-C2E6DE02C32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804526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r" rtl="1"/>
            <a:r>
              <a:rPr lang="he-IL" dirty="0"/>
              <a:t>מקרא מפה של </a:t>
            </a:r>
            <a:r>
              <a:rPr lang="en-US" dirty="0"/>
              <a:t>human array CXCL kit</a:t>
            </a:r>
            <a:r>
              <a:rPr lang="he-IL" dirty="0"/>
              <a:t>. </a:t>
            </a:r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4AA5E1-8F0C-47A9-8906-CFA3B421B7EA}" type="slidenum">
              <a:rPr lang="he-IL" smtClean="0"/>
              <a:t>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015912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r" rtl="1"/>
            <a:r>
              <a:rPr lang="he-IL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מקרא לשים מפה של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</a:t>
            </a:r>
            <a:r>
              <a:rPr lang="he-IL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של האתר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&amp;D</a:t>
            </a:r>
            <a:r>
              <a:rPr lang="he-IL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ATASHEET</a:t>
            </a:r>
            <a:r>
              <a:rPr lang="he-IL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XL human cytokine profile</a:t>
            </a:r>
          </a:p>
          <a:p>
            <a:pPr algn="l" rtl="0"/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algn="l" rt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FU fold: each group referred to CFU fold from CFU of the same bacteria without neutrophils. horizontal bars represent median for each group and vertical bars represent standard error. Each dot represents a different patient.</a:t>
            </a:r>
          </a:p>
          <a:p>
            <a:pPr algn="l" rt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% of necrotic cells: total of 3 repetitions for 8 different healthy and aggressive patients are included. Results present the percentage of necrotic cells in each group after 90 min incubation with 2 different bacteria. horizontal bars represent median and the vertical bars represent standard errors. Each dot represents different patient.</a:t>
            </a:r>
          </a:p>
          <a:p>
            <a:pPr algn="l" rt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***- statistical significance between marked groups with P&lt;0.0001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ld of % necrotic cells: total of 3 repetitions for 8 different healthy and aggressive patients are included. Results present the percentage of necrotic cells in each group after 90 min incubation with 2 different bacteria as a fold compared with JP2 inoculated AgP neutrophils. horizontal bars represent median and the vertical bars represent standard errors. Each dot represents different patient.</a:t>
            </a:r>
          </a:p>
          <a:p>
            <a:pPr algn="l" rt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ld change of AOC (area under the curve) of total ROS production. Fold analysis was done, setting “JP2 aggressive” as the reference points.</a:t>
            </a:r>
          </a:p>
          <a:p>
            <a:pPr algn="l" rt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orizontal bars represent median and vertical bars represent standard errors. Each dot represents different patient. </a:t>
            </a:r>
          </a:p>
          <a:p>
            <a:pPr algn="l" rt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*- statistical significance between groups with p&lt;0.001 </a:t>
            </a:r>
          </a:p>
          <a:p>
            <a:pPr algn="l" rt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ld change ROS production at 90min (left) and 150min (right). Fold analysis was done, setting “JP2 aggressive” as the reference points.</a:t>
            </a:r>
          </a:p>
          <a:p>
            <a:pPr algn="l" rt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orizontal bars represent median and vertical bars represent standard errors. Each dot represents different patient. </a:t>
            </a:r>
          </a:p>
          <a:p>
            <a:pPr algn="l" rt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- statistical significance between groups with p&lt;0.05 </a:t>
            </a:r>
          </a:p>
          <a:p>
            <a:pPr algn="l" rt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pPr algn="l" rtl="0"/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algn="l" rtl="0"/>
            <a:endParaRPr lang="he-IL" dirty="0"/>
          </a:p>
          <a:p>
            <a:pPr algn="l" rtl="0"/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algn="l" rt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pPr algn="l" rtl="0"/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pPr algn="l" rtl="0"/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4AA5E1-8F0C-47A9-8906-CFA3B421B7EA}" type="slidenum">
              <a:rPr lang="he-IL" smtClean="0"/>
              <a:t>4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912523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63EB-3877-4B67-B7E8-F190FE307776}" type="datetimeFigureOut">
              <a:rPr lang="he-IL" smtClean="0"/>
              <a:t>ב'/אדר ב/תשפ"ב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175A1-8807-4961-BDE2-9569F5023C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06794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63EB-3877-4B67-B7E8-F190FE307776}" type="datetimeFigureOut">
              <a:rPr lang="he-IL" smtClean="0"/>
              <a:t>ב'/אדר ב/תשפ"ב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175A1-8807-4961-BDE2-9569F5023C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68067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63EB-3877-4B67-B7E8-F190FE307776}" type="datetimeFigureOut">
              <a:rPr lang="he-IL" smtClean="0"/>
              <a:t>ב'/אדר ב/תשפ"ב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175A1-8807-4961-BDE2-9569F5023C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89350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63EB-3877-4B67-B7E8-F190FE307776}" type="datetimeFigureOut">
              <a:rPr lang="he-IL" smtClean="0"/>
              <a:t>ב'/אדר ב/תשפ"ב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175A1-8807-4961-BDE2-9569F5023C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94582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63EB-3877-4B67-B7E8-F190FE307776}" type="datetimeFigureOut">
              <a:rPr lang="he-IL" smtClean="0"/>
              <a:t>ב'/אדר ב/תשפ"ב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175A1-8807-4961-BDE2-9569F5023C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42472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63EB-3877-4B67-B7E8-F190FE307776}" type="datetimeFigureOut">
              <a:rPr lang="he-IL" smtClean="0"/>
              <a:t>ב'/אדר ב/תשפ"ב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175A1-8807-4961-BDE2-9569F5023C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42787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63EB-3877-4B67-B7E8-F190FE307776}" type="datetimeFigureOut">
              <a:rPr lang="he-IL" smtClean="0"/>
              <a:t>ב'/אדר ב/תשפ"ב</a:t>
            </a:fld>
            <a:endParaRPr lang="he-IL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175A1-8807-4961-BDE2-9569F5023C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77342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63EB-3877-4B67-B7E8-F190FE307776}" type="datetimeFigureOut">
              <a:rPr lang="he-IL" smtClean="0"/>
              <a:t>ב'/אדר ב/תשפ"ב</a:t>
            </a:fld>
            <a:endParaRPr lang="he-IL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175A1-8807-4961-BDE2-9569F5023C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64012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63EB-3877-4B67-B7E8-F190FE307776}" type="datetimeFigureOut">
              <a:rPr lang="he-IL" smtClean="0"/>
              <a:t>ב'/אדר ב/תשפ"ב</a:t>
            </a:fld>
            <a:endParaRPr lang="he-IL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175A1-8807-4961-BDE2-9569F5023C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63162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63EB-3877-4B67-B7E8-F190FE307776}" type="datetimeFigureOut">
              <a:rPr lang="he-IL" smtClean="0"/>
              <a:t>ב'/אדר ב/תשפ"ב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175A1-8807-4961-BDE2-9569F5023C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070239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63EB-3877-4B67-B7E8-F190FE307776}" type="datetimeFigureOut">
              <a:rPr lang="he-IL" smtClean="0"/>
              <a:t>ב'/אדר ב/תשפ"ב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175A1-8807-4961-BDE2-9569F5023C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979868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A863EB-3877-4B67-B7E8-F190FE307776}" type="datetimeFigureOut">
              <a:rPr lang="he-IL" smtClean="0"/>
              <a:t>ב'/אדר ב/תשפ"ב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0175A1-8807-4961-BDE2-9569F5023C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67298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7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r" defTabSz="914377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r" defTabSz="914377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r" defTabSz="914377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r" defTabSz="914377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r" defTabSz="914377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r" defTabSz="914377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r" defTabSz="914377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r" defTabSz="914377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r" defTabSz="914377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377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r" defTabSz="914377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r" defTabSz="914377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r" defTabSz="914377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r" defTabSz="914377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r" defTabSz="914377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r" defTabSz="914377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r" defTabSz="914377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r" defTabSz="914377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7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oleObject" Target="../embeddings/oleObject5.bin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oleObject" Target="../embeddings/oleObject8.bin"/><Relationship Id="rId7" Type="http://schemas.openxmlformats.org/officeDocument/2006/relationships/oleObject" Target="../embeddings/oleObject10.bin"/><Relationship Id="rId12" Type="http://schemas.openxmlformats.org/officeDocument/2006/relationships/image" Target="../media/image1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5.emf"/><Relationship Id="rId11" Type="http://schemas.openxmlformats.org/officeDocument/2006/relationships/oleObject" Target="../embeddings/oleObject12.bin"/><Relationship Id="rId5" Type="http://schemas.openxmlformats.org/officeDocument/2006/relationships/oleObject" Target="../embeddings/oleObject9.bin"/><Relationship Id="rId10" Type="http://schemas.openxmlformats.org/officeDocument/2006/relationships/image" Target="../media/image17.emf"/><Relationship Id="rId4" Type="http://schemas.openxmlformats.org/officeDocument/2006/relationships/image" Target="../media/image14.emf"/><Relationship Id="rId9" Type="http://schemas.openxmlformats.org/officeDocument/2006/relationships/oleObject" Target="../embeddings/oleObject11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3" Type="http://schemas.openxmlformats.org/officeDocument/2006/relationships/oleObject" Target="../embeddings/oleObject13.bin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2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0.emf"/><Relationship Id="rId11" Type="http://schemas.openxmlformats.org/officeDocument/2006/relationships/oleObject" Target="../embeddings/oleObject17.bin"/><Relationship Id="rId5" Type="http://schemas.openxmlformats.org/officeDocument/2006/relationships/oleObject" Target="../embeddings/oleObject14.bin"/><Relationship Id="rId10" Type="http://schemas.openxmlformats.org/officeDocument/2006/relationships/image" Target="../media/image22.emf"/><Relationship Id="rId4" Type="http://schemas.openxmlformats.org/officeDocument/2006/relationships/image" Target="../media/image19.emf"/><Relationship Id="rId9" Type="http://schemas.openxmlformats.org/officeDocument/2006/relationships/oleObject" Target="../embeddings/oleObject16.bin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16473" y="154034"/>
            <a:ext cx="2049024" cy="31963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477" b="1" dirty="0"/>
              <a:t>Supplementary Figure 1</a:t>
            </a:r>
            <a:endParaRPr lang="he-IL" sz="1477" b="1" dirty="0"/>
          </a:p>
        </p:txBody>
      </p:sp>
      <p:sp>
        <p:nvSpPr>
          <p:cNvPr id="17" name="תיבת טקסט 16">
            <a:extLst>
              <a:ext uri="{FF2B5EF4-FFF2-40B4-BE49-F238E27FC236}">
                <a16:creationId xmlns:a16="http://schemas.microsoft.com/office/drawing/2014/main" xmlns="" id="{D2494AD7-C5D9-4882-82B7-DE816B462667}"/>
              </a:ext>
            </a:extLst>
          </p:cNvPr>
          <p:cNvSpPr txBox="1"/>
          <p:nvPr/>
        </p:nvSpPr>
        <p:spPr>
          <a:xfrm>
            <a:off x="450042" y="524335"/>
            <a:ext cx="308098" cy="34823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63" dirty="0"/>
              <a:t>A</a:t>
            </a:r>
            <a:endParaRPr lang="he-IL" sz="1663" dirty="0"/>
          </a:p>
        </p:txBody>
      </p:sp>
      <p:pic>
        <p:nvPicPr>
          <p:cNvPr id="7" name="תמונה 6">
            <a:extLst>
              <a:ext uri="{FF2B5EF4-FFF2-40B4-BE49-F238E27FC236}">
                <a16:creationId xmlns:a16="http://schemas.microsoft.com/office/drawing/2014/main" xmlns="" id="{EA99AD56-53BC-4BEB-BB6C-FBC380E7CED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31153"/>
          <a:stretch/>
        </p:blipFill>
        <p:spPr>
          <a:xfrm>
            <a:off x="1340987" y="524336"/>
            <a:ext cx="3983517" cy="1787723"/>
          </a:xfrm>
          <a:prstGeom prst="rect">
            <a:avLst/>
          </a:prstGeom>
        </p:spPr>
      </p:pic>
      <p:sp>
        <p:nvSpPr>
          <p:cNvPr id="9" name="תיבת טקסט 8">
            <a:extLst>
              <a:ext uri="{FF2B5EF4-FFF2-40B4-BE49-F238E27FC236}">
                <a16:creationId xmlns:a16="http://schemas.microsoft.com/office/drawing/2014/main" xmlns="" id="{8492C6D6-A439-49A2-87ED-8F79EA052986}"/>
              </a:ext>
            </a:extLst>
          </p:cNvPr>
          <p:cNvSpPr txBox="1"/>
          <p:nvPr/>
        </p:nvSpPr>
        <p:spPr>
          <a:xfrm>
            <a:off x="484856" y="3109685"/>
            <a:ext cx="300082" cy="34823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63" dirty="0"/>
              <a:t>B</a:t>
            </a:r>
            <a:endParaRPr lang="he-IL" sz="1663" dirty="0"/>
          </a:p>
        </p:txBody>
      </p:sp>
      <p:grpSp>
        <p:nvGrpSpPr>
          <p:cNvPr id="15" name="קבוצה 14">
            <a:extLst>
              <a:ext uri="{FF2B5EF4-FFF2-40B4-BE49-F238E27FC236}">
                <a16:creationId xmlns:a16="http://schemas.microsoft.com/office/drawing/2014/main" xmlns="" id="{61AE1211-5D0C-4362-807A-27F023422930}"/>
              </a:ext>
            </a:extLst>
          </p:cNvPr>
          <p:cNvGrpSpPr/>
          <p:nvPr/>
        </p:nvGrpSpPr>
        <p:grpSpPr>
          <a:xfrm>
            <a:off x="836713" y="3176153"/>
            <a:ext cx="4918700" cy="3788729"/>
            <a:chOff x="620688" y="3440832"/>
            <a:chExt cx="5328592" cy="4104456"/>
          </a:xfrm>
        </p:grpSpPr>
        <p:pic>
          <p:nvPicPr>
            <p:cNvPr id="12" name="תמונה 11">
              <a:extLst>
                <a:ext uri="{FF2B5EF4-FFF2-40B4-BE49-F238E27FC236}">
                  <a16:creationId xmlns:a16="http://schemas.microsoft.com/office/drawing/2014/main" xmlns="" id="{16354106-BC1D-482C-B7A4-39B048532F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630" t="6357" r="22951" b="7860"/>
            <a:stretch/>
          </p:blipFill>
          <p:spPr>
            <a:xfrm>
              <a:off x="620688" y="3440832"/>
              <a:ext cx="2736304" cy="4104456"/>
            </a:xfrm>
            <a:prstGeom prst="rect">
              <a:avLst/>
            </a:prstGeom>
          </p:spPr>
        </p:pic>
        <p:pic>
          <p:nvPicPr>
            <p:cNvPr id="14" name="תמונה 13">
              <a:extLst>
                <a:ext uri="{FF2B5EF4-FFF2-40B4-BE49-F238E27FC236}">
                  <a16:creationId xmlns:a16="http://schemas.microsoft.com/office/drawing/2014/main" xmlns="" id="{3C5A722B-F9D7-4E9C-97DB-E620B976AC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080" t="6697" r="23367" b="19562"/>
            <a:stretch/>
          </p:blipFill>
          <p:spPr>
            <a:xfrm>
              <a:off x="3356991" y="3440832"/>
              <a:ext cx="2592289" cy="352839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886401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אובייקט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6596804"/>
              </p:ext>
            </p:extLst>
          </p:nvPr>
        </p:nvGraphicFramePr>
        <p:xfrm>
          <a:off x="2996952" y="229160"/>
          <a:ext cx="3265619" cy="23126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Prism 6" r:id="rId3" imgW="4765676" imgH="3375724" progId="Prism6.Document">
                  <p:embed/>
                </p:oleObj>
              </mc:Choice>
              <mc:Fallback>
                <p:oleObj name="Prism 6" r:id="rId3" imgW="4765676" imgH="3375724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96952" y="229160"/>
                        <a:ext cx="3265619" cy="231269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אובייקט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2048197"/>
              </p:ext>
            </p:extLst>
          </p:nvPr>
        </p:nvGraphicFramePr>
        <p:xfrm>
          <a:off x="1124744" y="6372201"/>
          <a:ext cx="3886939" cy="2906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name="Prism 6" r:id="rId5" imgW="5672858" imgH="4241534" progId="Prism6.Document">
                  <p:embed/>
                </p:oleObj>
              </mc:Choice>
              <mc:Fallback>
                <p:oleObj name="Prism 6" r:id="rId5" imgW="5672858" imgH="4241534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24744" y="6372201"/>
                        <a:ext cx="3886939" cy="29069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אובייקט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800349"/>
              </p:ext>
            </p:extLst>
          </p:nvPr>
        </p:nvGraphicFramePr>
        <p:xfrm>
          <a:off x="836712" y="2339752"/>
          <a:ext cx="4648789" cy="21720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6" r:id="rId7" imgW="6784237" imgH="3168275" progId="Prism6.Document">
                  <p:embed/>
                </p:oleObj>
              </mc:Choice>
              <mc:Fallback>
                <p:oleObj name="Prism 6" r:id="rId7" imgW="6784237" imgH="3168275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36712" y="2339752"/>
                        <a:ext cx="4648789" cy="217202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אובייקט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1662444"/>
              </p:ext>
            </p:extLst>
          </p:nvPr>
        </p:nvGraphicFramePr>
        <p:xfrm>
          <a:off x="764705" y="4355977"/>
          <a:ext cx="4699580" cy="21257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Prism 6" r:id="rId9" imgW="6857704" imgH="3102727" progId="Prism6.Document">
                  <p:embed/>
                </p:oleObj>
              </mc:Choice>
              <mc:Fallback>
                <p:oleObj name="Prism 6" r:id="rId9" imgW="6857704" imgH="3102727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64705" y="4355977"/>
                        <a:ext cx="4699580" cy="212571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316473" y="154034"/>
            <a:ext cx="2049024" cy="31963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477" b="1" dirty="0"/>
              <a:t>Supplementary Figure 1</a:t>
            </a:r>
            <a:endParaRPr lang="he-IL" sz="1477" b="1" dirty="0"/>
          </a:p>
        </p:txBody>
      </p:sp>
      <p:sp>
        <p:nvSpPr>
          <p:cNvPr id="9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2189766" y="1161345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  <p:sp>
        <p:nvSpPr>
          <p:cNvPr id="11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80629" y="3050863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  <p:sp>
        <p:nvSpPr>
          <p:cNvPr id="12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44834" y="5067087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  <p:sp>
        <p:nvSpPr>
          <p:cNvPr id="13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326850" y="7088965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</p:spTree>
    <p:extLst>
      <p:ext uri="{BB962C8B-B14F-4D97-AF65-F5344CB8AC3E}">
        <p14:creationId xmlns:p14="http://schemas.microsoft.com/office/powerpoint/2010/main" val="39277479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אובייקט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6671497"/>
              </p:ext>
            </p:extLst>
          </p:nvPr>
        </p:nvGraphicFramePr>
        <p:xfrm>
          <a:off x="1484785" y="3491880"/>
          <a:ext cx="3836148" cy="22497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2" name="Prism 6" r:id="rId3" imgW="5599750" imgH="3281003" progId="Prism6.Document">
                  <p:embed/>
                </p:oleObj>
              </mc:Choice>
              <mc:Fallback>
                <p:oleObj name="Prism 6" r:id="rId3" imgW="5599750" imgH="3281003" progId="Prism6.Document">
                  <p:embed/>
                  <p:pic>
                    <p:nvPicPr>
                      <p:cNvPr id="0" name="אובייקט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84785" y="3491880"/>
                        <a:ext cx="3836148" cy="224970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אובייקט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7081837"/>
              </p:ext>
            </p:extLst>
          </p:nvPr>
        </p:nvGraphicFramePr>
        <p:xfrm>
          <a:off x="1124745" y="5868145"/>
          <a:ext cx="4230519" cy="28502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3" name="Prism 6" r:id="rId5" imgW="6173086" imgH="4159419" progId="Prism6.Document">
                  <p:embed/>
                </p:oleObj>
              </mc:Choice>
              <mc:Fallback>
                <p:oleObj name="Prism 6" r:id="rId5" imgW="6173086" imgH="4159419" progId="Prism6.Document">
                  <p:embed/>
                  <p:pic>
                    <p:nvPicPr>
                      <p:cNvPr id="0" name="אובייקט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24745" y="5868145"/>
                        <a:ext cx="4230519" cy="285022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אובייקט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4054243"/>
              </p:ext>
            </p:extLst>
          </p:nvPr>
        </p:nvGraphicFramePr>
        <p:xfrm>
          <a:off x="1484784" y="827585"/>
          <a:ext cx="3888432" cy="27351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4" name="Prism 6" r:id="rId7" imgW="5672858" imgH="3991587" progId="Prism6.Document">
                  <p:embed/>
                </p:oleObj>
              </mc:Choice>
              <mc:Fallback>
                <p:oleObj name="Prism 6" r:id="rId7" imgW="5672858" imgH="3991587" progId="Prism6.Document">
                  <p:embed/>
                  <p:pic>
                    <p:nvPicPr>
                      <p:cNvPr id="0" name="אובייקט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84784" y="827585"/>
                        <a:ext cx="3888432" cy="27351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316473" y="154034"/>
            <a:ext cx="2049024" cy="31963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477" b="1" dirty="0"/>
              <a:t>Supplementary Figure 1</a:t>
            </a:r>
            <a:endParaRPr lang="he-IL" sz="1477" b="1" dirty="0"/>
          </a:p>
        </p:txBody>
      </p:sp>
      <p:sp>
        <p:nvSpPr>
          <p:cNvPr id="7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708275" y="4345448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  <p:sp>
        <p:nvSpPr>
          <p:cNvPr id="8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715899" y="6650809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  <p:sp>
        <p:nvSpPr>
          <p:cNvPr id="11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705364" y="1562893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</p:spTree>
    <p:extLst>
      <p:ext uri="{BB962C8B-B14F-4D97-AF65-F5344CB8AC3E}">
        <p14:creationId xmlns:p14="http://schemas.microsoft.com/office/powerpoint/2010/main" val="19789197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7096" y="154034"/>
            <a:ext cx="2219776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600" b="1" dirty="0"/>
              <a:t>Supplementary Figure 2</a:t>
            </a:r>
            <a:endParaRPr lang="he-IL" sz="1600" b="1" dirty="0"/>
          </a:p>
        </p:txBody>
      </p:sp>
      <p:sp>
        <p:nvSpPr>
          <p:cNvPr id="17" name="תיבת טקסט 16">
            <a:extLst>
              <a:ext uri="{FF2B5EF4-FFF2-40B4-BE49-F238E27FC236}">
                <a16:creationId xmlns:a16="http://schemas.microsoft.com/office/drawing/2014/main" xmlns="" id="{D2494AD7-C5D9-4882-82B7-DE816B462667}"/>
              </a:ext>
            </a:extLst>
          </p:cNvPr>
          <p:cNvSpPr txBox="1"/>
          <p:nvPr/>
        </p:nvSpPr>
        <p:spPr>
          <a:xfrm>
            <a:off x="217852" y="524333"/>
            <a:ext cx="31771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A</a:t>
            </a:r>
            <a:endParaRPr lang="he-IL" dirty="0"/>
          </a:p>
        </p:txBody>
      </p:sp>
      <p:pic>
        <p:nvPicPr>
          <p:cNvPr id="3" name="תמונה 2">
            <a:extLst>
              <a:ext uri="{FF2B5EF4-FFF2-40B4-BE49-F238E27FC236}">
                <a16:creationId xmlns:a16="http://schemas.microsoft.com/office/drawing/2014/main" xmlns="" id="{C85681E8-9EDF-4D05-AC76-53A32CF209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0054" y="527060"/>
            <a:ext cx="5717895" cy="2033179"/>
          </a:xfrm>
          <a:prstGeom prst="rect">
            <a:avLst/>
          </a:prstGeom>
        </p:spPr>
      </p:pic>
      <p:sp>
        <p:nvSpPr>
          <p:cNvPr id="8" name="תיבת טקסט 7">
            <a:extLst>
              <a:ext uri="{FF2B5EF4-FFF2-40B4-BE49-F238E27FC236}">
                <a16:creationId xmlns:a16="http://schemas.microsoft.com/office/drawing/2014/main" xmlns="" id="{1294CE05-8D47-4F79-B712-4015F71C662B}"/>
              </a:ext>
            </a:extLst>
          </p:cNvPr>
          <p:cNvSpPr txBox="1"/>
          <p:nvPr/>
        </p:nvSpPr>
        <p:spPr>
          <a:xfrm>
            <a:off x="260353" y="3708005"/>
            <a:ext cx="309700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B</a:t>
            </a:r>
            <a:endParaRPr lang="he-IL" dirty="0"/>
          </a:p>
        </p:txBody>
      </p:sp>
      <p:grpSp>
        <p:nvGrpSpPr>
          <p:cNvPr id="11" name="קבוצה 10">
            <a:extLst>
              <a:ext uri="{FF2B5EF4-FFF2-40B4-BE49-F238E27FC236}">
                <a16:creationId xmlns:a16="http://schemas.microsoft.com/office/drawing/2014/main" xmlns="" id="{72B9346F-FF9C-416E-B951-970806A4F1BB}"/>
              </a:ext>
            </a:extLst>
          </p:cNvPr>
          <p:cNvGrpSpPr/>
          <p:nvPr/>
        </p:nvGrpSpPr>
        <p:grpSpPr>
          <a:xfrm>
            <a:off x="166328" y="4239657"/>
            <a:ext cx="6525344" cy="3895953"/>
            <a:chOff x="332656" y="4664968"/>
            <a:chExt cx="6525344" cy="4220616"/>
          </a:xfrm>
        </p:grpSpPr>
        <p:pic>
          <p:nvPicPr>
            <p:cNvPr id="6" name="תמונה 5">
              <a:extLst>
                <a:ext uri="{FF2B5EF4-FFF2-40B4-BE49-F238E27FC236}">
                  <a16:creationId xmlns:a16="http://schemas.microsoft.com/office/drawing/2014/main" xmlns="" id="{5164F90C-8B43-4241-B658-7C1B8BF376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355" t="9030" r="5704" b="8199"/>
            <a:stretch/>
          </p:blipFill>
          <p:spPr>
            <a:xfrm>
              <a:off x="332656" y="4664968"/>
              <a:ext cx="3456384" cy="4176464"/>
            </a:xfrm>
            <a:prstGeom prst="rect">
              <a:avLst/>
            </a:prstGeom>
          </p:spPr>
        </p:pic>
        <p:pic>
          <p:nvPicPr>
            <p:cNvPr id="9" name="תמונה 8">
              <a:extLst>
                <a:ext uri="{FF2B5EF4-FFF2-40B4-BE49-F238E27FC236}">
                  <a16:creationId xmlns:a16="http://schemas.microsoft.com/office/drawing/2014/main" xmlns="" id="{6CD34AA1-080C-4975-86AF-4797ADE85F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6341" t="6912" r="7453" b="25365"/>
            <a:stretch/>
          </p:blipFill>
          <p:spPr>
            <a:xfrm>
              <a:off x="3645023" y="4664968"/>
              <a:ext cx="3212977" cy="3240360"/>
            </a:xfrm>
            <a:prstGeom prst="rect">
              <a:avLst/>
            </a:prstGeom>
          </p:spPr>
        </p:pic>
        <p:sp>
          <p:nvSpPr>
            <p:cNvPr id="10" name="מלבן 9">
              <a:extLst>
                <a:ext uri="{FF2B5EF4-FFF2-40B4-BE49-F238E27FC236}">
                  <a16:creationId xmlns:a16="http://schemas.microsoft.com/office/drawing/2014/main" xmlns="" id="{69914665-12FF-45C9-842B-965EA79EB268}"/>
                </a:ext>
              </a:extLst>
            </p:cNvPr>
            <p:cNvSpPr/>
            <p:nvPr/>
          </p:nvSpPr>
          <p:spPr>
            <a:xfrm>
              <a:off x="3690069" y="7905328"/>
              <a:ext cx="3096344" cy="720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2" name="מלבן 11">
              <a:extLst>
                <a:ext uri="{FF2B5EF4-FFF2-40B4-BE49-F238E27FC236}">
                  <a16:creationId xmlns:a16="http://schemas.microsoft.com/office/drawing/2014/main" xmlns="" id="{8671F49A-E595-4821-80D4-52CB82CF1072}"/>
                </a:ext>
              </a:extLst>
            </p:cNvPr>
            <p:cNvSpPr/>
            <p:nvPr/>
          </p:nvSpPr>
          <p:spPr>
            <a:xfrm>
              <a:off x="376710" y="8813576"/>
              <a:ext cx="3096344" cy="720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</p:grpSp>
    </p:spTree>
    <p:extLst>
      <p:ext uri="{BB962C8B-B14F-4D97-AF65-F5344CB8AC3E}">
        <p14:creationId xmlns:p14="http://schemas.microsoft.com/office/powerpoint/2010/main" val="15879067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xmlns="" id="{1E19064C-22E3-4228-9B30-0C2CF61B3C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9676942"/>
              </p:ext>
            </p:extLst>
          </p:nvPr>
        </p:nvGraphicFramePr>
        <p:xfrm>
          <a:off x="716823" y="499967"/>
          <a:ext cx="2668925" cy="25303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9" name="Prism 6" r:id="rId3" imgW="3302084" imgH="3130099" progId="Prism6.Document">
                  <p:embed/>
                </p:oleObj>
              </mc:Choice>
              <mc:Fallback>
                <p:oleObj name="Prism 6" r:id="rId3" imgW="3302084" imgH="313009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16823" y="499967"/>
                        <a:ext cx="2668925" cy="25303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xmlns="" id="{A3C0BFD8-9790-458E-B10F-C53593A7602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777593"/>
              </p:ext>
            </p:extLst>
          </p:nvPr>
        </p:nvGraphicFramePr>
        <p:xfrm>
          <a:off x="3796225" y="3214617"/>
          <a:ext cx="2668925" cy="26535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0" name="Prism 6" r:id="rId5" imgW="3302084" imgH="3282444" progId="Prism6.Document">
                  <p:embed/>
                </p:oleObj>
              </mc:Choice>
              <mc:Fallback>
                <p:oleObj name="Prism 6" r:id="rId5" imgW="3302084" imgH="3282444" progId="Prism6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xmlns="" id="{510AE323-1CF6-4811-B452-17B5A189B02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96225" y="3214617"/>
                        <a:ext cx="2668925" cy="26535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xmlns="" id="{8728A570-9D55-48D1-8711-B3A492DBCE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8449574"/>
              </p:ext>
            </p:extLst>
          </p:nvPr>
        </p:nvGraphicFramePr>
        <p:xfrm>
          <a:off x="536436" y="3154093"/>
          <a:ext cx="2804937" cy="26265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1" name="Prism 6" r:id="rId7" imgW="3469908" imgH="3248950" progId="Prism6.Document">
                  <p:embed/>
                </p:oleObj>
              </mc:Choice>
              <mc:Fallback>
                <p:oleObj name="Prism 6" r:id="rId7" imgW="3469908" imgH="3248950" progId="Prism6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xmlns="" id="{F4146D99-2D26-43D0-B7C2-C020D81D33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36436" y="3154093"/>
                        <a:ext cx="2804937" cy="26265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xmlns="" id="{6B06DE02-3A79-46AF-96F7-4577CD0C59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5113055"/>
              </p:ext>
            </p:extLst>
          </p:nvPr>
        </p:nvGraphicFramePr>
        <p:xfrm>
          <a:off x="3341373" y="542259"/>
          <a:ext cx="3037185" cy="2643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2" name="Prism 6" r:id="rId9" imgW="3758016" imgH="3270559" progId="Prism6.Document">
                  <p:embed/>
                </p:oleObj>
              </mc:Choice>
              <mc:Fallback>
                <p:oleObj name="Prism 6" r:id="rId9" imgW="3758016" imgH="3270559" progId="Prism6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xmlns="" id="{40F4750E-4E8F-4679-AF53-F65D77EC1E5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341373" y="542259"/>
                        <a:ext cx="3037185" cy="2643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xmlns="" id="{F29A42AE-78E3-4693-B691-2B16C5AC3E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691448"/>
              </p:ext>
            </p:extLst>
          </p:nvPr>
        </p:nvGraphicFramePr>
        <p:xfrm>
          <a:off x="2119247" y="5796136"/>
          <a:ext cx="2668925" cy="2643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3" name="Prism 6" r:id="rId11" imgW="3302084" imgH="3270559" progId="Prism6.Document">
                  <p:embed/>
                </p:oleObj>
              </mc:Choice>
              <mc:Fallback>
                <p:oleObj name="Prism 6" r:id="rId11" imgW="3302084" imgH="3270559" progId="Prism6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xmlns="" id="{9567427A-67A0-4E74-B167-CF546409D1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119247" y="5796136"/>
                        <a:ext cx="2668925" cy="2643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822699E3-0465-4B34-85B2-372FA51A2489}"/>
              </a:ext>
            </a:extLst>
          </p:cNvPr>
          <p:cNvSpPr txBox="1"/>
          <p:nvPr/>
        </p:nvSpPr>
        <p:spPr>
          <a:xfrm>
            <a:off x="57096" y="154034"/>
            <a:ext cx="2219776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600" b="1" dirty="0"/>
              <a:t>Supplementary Figure 2</a:t>
            </a:r>
            <a:endParaRPr lang="he-IL" sz="1600" b="1" dirty="0"/>
          </a:p>
        </p:txBody>
      </p:sp>
      <p:sp>
        <p:nvSpPr>
          <p:cNvPr id="8" name="תיבת טקסט 16">
            <a:extLst>
              <a:ext uri="{FF2B5EF4-FFF2-40B4-BE49-F238E27FC236}">
                <a16:creationId xmlns:a16="http://schemas.microsoft.com/office/drawing/2014/main" xmlns="" id="{93BE1470-2097-427C-8E29-F90FA3F2551A}"/>
              </a:ext>
            </a:extLst>
          </p:cNvPr>
          <p:cNvSpPr txBox="1"/>
          <p:nvPr/>
        </p:nvSpPr>
        <p:spPr>
          <a:xfrm>
            <a:off x="217852" y="524333"/>
            <a:ext cx="31771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C</a:t>
            </a:r>
            <a:endParaRPr lang="he-IL" dirty="0"/>
          </a:p>
        </p:txBody>
      </p:sp>
      <p:sp>
        <p:nvSpPr>
          <p:cNvPr id="9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-61129" y="1294126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  <p:sp>
        <p:nvSpPr>
          <p:cNvPr id="10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2892744" y="1265567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  <p:sp>
        <p:nvSpPr>
          <p:cNvPr id="11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-168114" y="3908829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  <p:sp>
        <p:nvSpPr>
          <p:cNvPr id="12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3015856" y="3861583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</p:spTree>
    <p:extLst>
      <p:ext uri="{BB962C8B-B14F-4D97-AF65-F5344CB8AC3E}">
        <p14:creationId xmlns:p14="http://schemas.microsoft.com/office/powerpoint/2010/main" val="22980357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xmlns="" id="{40B5446D-1133-4E3D-A970-8B1BB2B7D4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7439055"/>
              </p:ext>
            </p:extLst>
          </p:nvPr>
        </p:nvGraphicFramePr>
        <p:xfrm>
          <a:off x="627374" y="395536"/>
          <a:ext cx="2711536" cy="2543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9" name="Prism 6" r:id="rId3" imgW="3302084" imgH="3096604" progId="Prism6.Document">
                  <p:embed/>
                </p:oleObj>
              </mc:Choice>
              <mc:Fallback>
                <p:oleObj name="Prism 6" r:id="rId3" imgW="3302084" imgH="309660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7374" y="395536"/>
                        <a:ext cx="2711536" cy="2543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xmlns="" id="{73F5CB47-9408-4874-9D80-016DEB7982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1107034"/>
              </p:ext>
            </p:extLst>
          </p:nvPr>
        </p:nvGraphicFramePr>
        <p:xfrm>
          <a:off x="3885816" y="395536"/>
          <a:ext cx="2711536" cy="27988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30" name="Prism 6" r:id="rId5" imgW="3302084" imgH="3407778" progId="Prism6.Document">
                  <p:embed/>
                </p:oleObj>
              </mc:Choice>
              <mc:Fallback>
                <p:oleObj name="Prism 6" r:id="rId5" imgW="3302084" imgH="3407778" progId="Prism6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xmlns="" id="{9AB5E2D0-2DDF-4DDB-8557-DEB4FC56F9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85816" y="395536"/>
                        <a:ext cx="2711536" cy="27988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xmlns="" id="{3A690599-11D6-443E-AE21-02C6242942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5706632"/>
              </p:ext>
            </p:extLst>
          </p:nvPr>
        </p:nvGraphicFramePr>
        <p:xfrm>
          <a:off x="582225" y="2938904"/>
          <a:ext cx="2835380" cy="27363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31" name="Prism 6" r:id="rId7" imgW="3453341" imgH="3331425" progId="Prism6.Document">
                  <p:embed/>
                </p:oleObj>
              </mc:Choice>
              <mc:Fallback>
                <p:oleObj name="Prism 6" r:id="rId7" imgW="3453341" imgH="3331425" progId="Prism6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xmlns="" id="{EB7EC3B2-BEC1-44A9-A302-8011DEE923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82225" y="2938904"/>
                        <a:ext cx="2835380" cy="27363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xmlns="" id="{7A6F6F4B-FD99-42EE-A849-A106027BE3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61"/>
              </p:ext>
            </p:extLst>
          </p:nvPr>
        </p:nvGraphicFramePr>
        <p:xfrm>
          <a:off x="3310062" y="2805934"/>
          <a:ext cx="3268183" cy="28692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32" name="Prism 6" r:id="rId9" imgW="3980580" imgH="3494575" progId="Prism6.Document">
                  <p:embed/>
                </p:oleObj>
              </mc:Choice>
              <mc:Fallback>
                <p:oleObj name="Prism 6" r:id="rId9" imgW="3980580" imgH="3494575" progId="Prism6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xmlns="" id="{8E7C667F-1516-4A60-B879-B29495088D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310062" y="2805934"/>
                        <a:ext cx="3268183" cy="28692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xmlns="" id="{9C08EF3F-C3E7-4690-B026-99509FACD8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0693208"/>
              </p:ext>
            </p:extLst>
          </p:nvPr>
        </p:nvGraphicFramePr>
        <p:xfrm>
          <a:off x="1917941" y="5604812"/>
          <a:ext cx="3135213" cy="33177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33" name="Prism 6" r:id="rId11" imgW="3817439" imgH="4040208" progId="Prism6.Document">
                  <p:embed/>
                </p:oleObj>
              </mc:Choice>
              <mc:Fallback>
                <p:oleObj name="Prism 6" r:id="rId11" imgW="3817439" imgH="4040208" progId="Prism6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xmlns="" id="{4F2779AA-14CA-4E67-9FA8-94F91C92C76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917941" y="5604812"/>
                        <a:ext cx="3135213" cy="33177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433166DE-1E1C-4FD9-8499-561F07649248}"/>
              </a:ext>
            </a:extLst>
          </p:cNvPr>
          <p:cNvSpPr txBox="1"/>
          <p:nvPr/>
        </p:nvSpPr>
        <p:spPr>
          <a:xfrm>
            <a:off x="57096" y="154034"/>
            <a:ext cx="2219776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600" b="1" dirty="0"/>
              <a:t>Supplementary Figure 2</a:t>
            </a:r>
            <a:endParaRPr lang="he-IL" sz="1600" b="1" dirty="0"/>
          </a:p>
        </p:txBody>
      </p:sp>
      <p:sp>
        <p:nvSpPr>
          <p:cNvPr id="8" name="תיבת טקסט 16">
            <a:extLst>
              <a:ext uri="{FF2B5EF4-FFF2-40B4-BE49-F238E27FC236}">
                <a16:creationId xmlns:a16="http://schemas.microsoft.com/office/drawing/2014/main" xmlns="" id="{D73BF895-69C6-4ED9-8AE6-57367A01977E}"/>
              </a:ext>
            </a:extLst>
          </p:cNvPr>
          <p:cNvSpPr txBox="1"/>
          <p:nvPr/>
        </p:nvSpPr>
        <p:spPr>
          <a:xfrm>
            <a:off x="217852" y="524333"/>
            <a:ext cx="31771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C</a:t>
            </a:r>
            <a:endParaRPr lang="he-IL" dirty="0"/>
          </a:p>
        </p:txBody>
      </p:sp>
      <p:sp>
        <p:nvSpPr>
          <p:cNvPr id="9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-148508" y="1053553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  <p:sp>
        <p:nvSpPr>
          <p:cNvPr id="10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3095625" y="1104663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  <p:sp>
        <p:nvSpPr>
          <p:cNvPr id="11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-56701" y="3738269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  <p:sp>
        <p:nvSpPr>
          <p:cNvPr id="12" name="TextBox 4">
            <a:extLst>
              <a:ext uri="{FF2B5EF4-FFF2-40B4-BE49-F238E27FC236}">
                <a16:creationId xmlns:a16="http://schemas.microsoft.com/office/drawing/2014/main" xmlns="" id="{44C95C5B-1FF9-4C2E-A221-B46217FD7918}"/>
              </a:ext>
            </a:extLst>
          </p:cNvPr>
          <p:cNvSpPr txBox="1"/>
          <p:nvPr/>
        </p:nvSpPr>
        <p:spPr>
          <a:xfrm rot="16200000">
            <a:off x="3120532" y="3508603"/>
            <a:ext cx="1368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/>
              <a:t>Pixel size</a:t>
            </a:r>
            <a:endParaRPr lang="x-none" sz="1000" b="1" dirty="0"/>
          </a:p>
        </p:txBody>
      </p:sp>
    </p:spTree>
    <p:extLst>
      <p:ext uri="{BB962C8B-B14F-4D97-AF65-F5344CB8AC3E}">
        <p14:creationId xmlns:p14="http://schemas.microsoft.com/office/powerpoint/2010/main" val="3793378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822699E3-0465-4B34-85B2-372FA51A2489}"/>
              </a:ext>
            </a:extLst>
          </p:cNvPr>
          <p:cNvSpPr txBox="1"/>
          <p:nvPr/>
        </p:nvSpPr>
        <p:spPr>
          <a:xfrm>
            <a:off x="57096" y="154034"/>
            <a:ext cx="2219776" cy="33855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600" b="1" dirty="0"/>
              <a:t>Supplementary Figure </a:t>
            </a:r>
            <a:r>
              <a:rPr lang="en-US" sz="1600" b="1" dirty="0" smtClean="0"/>
              <a:t>3</a:t>
            </a:r>
            <a:endParaRPr lang="he-IL" sz="16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C2E17AD4-7D99-41B5-A923-F158AEED099F}"/>
              </a:ext>
            </a:extLst>
          </p:cNvPr>
          <p:cNvSpPr txBox="1"/>
          <p:nvPr/>
        </p:nvSpPr>
        <p:spPr>
          <a:xfrm rot="16200000">
            <a:off x="1202989" y="4614019"/>
            <a:ext cx="13774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w/o quenching</a:t>
            </a:r>
            <a:endParaRPr lang="x-none" sz="14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D2908CFB-D577-40E3-A373-F52284F598E5}"/>
              </a:ext>
            </a:extLst>
          </p:cNvPr>
          <p:cNvSpPr txBox="1"/>
          <p:nvPr/>
        </p:nvSpPr>
        <p:spPr>
          <a:xfrm rot="16200000">
            <a:off x="1202987" y="6062931"/>
            <a:ext cx="13774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with quenching</a:t>
            </a:r>
            <a:endParaRPr lang="x-none" sz="1400" b="1" dirty="0"/>
          </a:p>
        </p:txBody>
      </p:sp>
      <p:pic>
        <p:nvPicPr>
          <p:cNvPr id="12" name="Picture 44">
            <a:extLst>
              <a:ext uri="{FF2B5EF4-FFF2-40B4-BE49-F238E27FC236}">
                <a16:creationId xmlns:a16="http://schemas.microsoft.com/office/drawing/2014/main" xmlns="" id="{D6ACABC0-C21D-409E-BE02-187C6D92FC3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73872" b="53168"/>
          <a:stretch/>
        </p:blipFill>
        <p:spPr>
          <a:xfrm>
            <a:off x="1986853" y="2001376"/>
            <a:ext cx="1791816" cy="171062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AA46CEE3-8132-4885-9C53-0DDDE287F97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50" t="50682" r="48950"/>
          <a:stretch/>
        </p:blipFill>
        <p:spPr>
          <a:xfrm>
            <a:off x="2067942" y="5455427"/>
            <a:ext cx="1844824" cy="180142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65955FDD-0AF9-4DC8-AF2D-003CC7F5B7A1}"/>
              </a:ext>
            </a:extLst>
          </p:cNvPr>
          <p:cNvSpPr txBox="1"/>
          <p:nvPr/>
        </p:nvSpPr>
        <p:spPr>
          <a:xfrm rot="16200000">
            <a:off x="1464899" y="2731900"/>
            <a:ext cx="158417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SSC</a:t>
            </a:r>
            <a:endParaRPr lang="x-none" sz="8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36BEAE78-7E0A-4261-952D-368BFEE7D5BB}"/>
              </a:ext>
            </a:extLst>
          </p:cNvPr>
          <p:cNvSpPr txBox="1"/>
          <p:nvPr/>
        </p:nvSpPr>
        <p:spPr>
          <a:xfrm>
            <a:off x="2181121" y="3402511"/>
            <a:ext cx="158417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FSC</a:t>
            </a:r>
            <a:endParaRPr lang="x-none" sz="800" b="1" dirty="0"/>
          </a:p>
        </p:txBody>
      </p:sp>
      <p:pic>
        <p:nvPicPr>
          <p:cNvPr id="16" name="Picture 45">
            <a:extLst>
              <a:ext uri="{FF2B5EF4-FFF2-40B4-BE49-F238E27FC236}">
                <a16:creationId xmlns:a16="http://schemas.microsoft.com/office/drawing/2014/main" xmlns="" id="{6301994F-11A6-4375-B496-EA1FEA3B323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38" r="48950" b="52227"/>
          <a:stretch/>
        </p:blipFill>
        <p:spPr>
          <a:xfrm>
            <a:off x="2219578" y="3816828"/>
            <a:ext cx="1516442" cy="174498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7B84D6D4-997F-4E5D-ACB1-5746AFF6F7A5}"/>
              </a:ext>
            </a:extLst>
          </p:cNvPr>
          <p:cNvSpPr txBox="1"/>
          <p:nvPr/>
        </p:nvSpPr>
        <p:spPr>
          <a:xfrm rot="16200000">
            <a:off x="1422391" y="4514429"/>
            <a:ext cx="158417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JP2 (FITC)</a:t>
            </a:r>
            <a:endParaRPr lang="x-none" sz="8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F108A7E5-BB0A-498C-8384-26EDA19EF5D5}"/>
              </a:ext>
            </a:extLst>
          </p:cNvPr>
          <p:cNvSpPr txBox="1"/>
          <p:nvPr/>
        </p:nvSpPr>
        <p:spPr>
          <a:xfrm rot="16200000">
            <a:off x="1444465" y="6188369"/>
            <a:ext cx="158417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JP2 (FITC)</a:t>
            </a:r>
            <a:endParaRPr lang="x-none" sz="8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EE103414-BDF5-428B-A54C-D8610264CE36}"/>
              </a:ext>
            </a:extLst>
          </p:cNvPr>
          <p:cNvSpPr txBox="1"/>
          <p:nvPr/>
        </p:nvSpPr>
        <p:spPr>
          <a:xfrm>
            <a:off x="2161373" y="5306517"/>
            <a:ext cx="158417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FSC</a:t>
            </a:r>
            <a:endParaRPr lang="x-none" sz="8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7847001E-C7B7-4D9D-BDA5-6A41DEE79A98}"/>
              </a:ext>
            </a:extLst>
          </p:cNvPr>
          <p:cNvSpPr txBox="1"/>
          <p:nvPr/>
        </p:nvSpPr>
        <p:spPr>
          <a:xfrm>
            <a:off x="2096043" y="6969403"/>
            <a:ext cx="158417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FSC</a:t>
            </a:r>
            <a:endParaRPr lang="x-none" sz="800" b="1" dirty="0"/>
          </a:p>
        </p:txBody>
      </p:sp>
      <p:cxnSp>
        <p:nvCxnSpPr>
          <p:cNvPr id="23" name="Straight Connector 51">
            <a:extLst>
              <a:ext uri="{FF2B5EF4-FFF2-40B4-BE49-F238E27FC236}">
                <a16:creationId xmlns:a16="http://schemas.microsoft.com/office/drawing/2014/main" xmlns="" id="{ED25FB58-6BB8-4CD9-8A14-77823D5A365C}"/>
              </a:ext>
            </a:extLst>
          </p:cNvPr>
          <p:cNvCxnSpPr/>
          <p:nvPr/>
        </p:nvCxnSpPr>
        <p:spPr>
          <a:xfrm flipH="1">
            <a:off x="3577885" y="3944487"/>
            <a:ext cx="19959" cy="3263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BBA71958-F61C-4805-A585-66AC4D427644}"/>
              </a:ext>
            </a:extLst>
          </p:cNvPr>
          <p:cNvSpPr txBox="1"/>
          <p:nvPr/>
        </p:nvSpPr>
        <p:spPr>
          <a:xfrm>
            <a:off x="2310702" y="3729167"/>
            <a:ext cx="1431289" cy="194051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b="1" dirty="0">
                <a:solidFill>
                  <a:schemeClr val="tx1"/>
                </a:solidFill>
              </a:rPr>
              <a:t>dHL60</a:t>
            </a:r>
            <a:r>
              <a:rPr lang="en-US" sz="1200" b="1" dirty="0">
                <a:solidFill>
                  <a:srgbClr val="FF0000"/>
                </a:solidFill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307888266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374</Words>
  <Application>Microsoft Office PowerPoint</Application>
  <PresentationFormat>‫הצגה על המסך (4:3)</PresentationFormat>
  <Paragraphs>59</Paragraphs>
  <Slides>7</Slides>
  <Notes>2</Notes>
  <HiddenSlides>0</HiddenSlides>
  <MMClips>0</MMClips>
  <ScaleCrop>false</ScaleCrop>
  <HeadingPairs>
    <vt:vector size="6" baseType="variant">
      <vt:variant>
        <vt:lpstr>ערכת נושא</vt:lpstr>
      </vt:variant>
      <vt:variant>
        <vt:i4>1</vt:i4>
      </vt:variant>
      <vt:variant>
        <vt:lpstr>שרתי OLE מוטבעים</vt:lpstr>
      </vt:variant>
      <vt:variant>
        <vt:i4>1</vt:i4>
      </vt:variant>
      <vt:variant>
        <vt:lpstr>כותרות שקופיות</vt:lpstr>
      </vt:variant>
      <vt:variant>
        <vt:i4>7</vt:i4>
      </vt:variant>
    </vt:vector>
  </HeadingPairs>
  <TitlesOfParts>
    <vt:vector size="9" baseType="lpstr">
      <vt:lpstr>ערכת נושא Office</vt:lpstr>
      <vt:lpstr>Prism 6</vt:lpstr>
      <vt:lpstr>מצגת של PowerPoint</vt:lpstr>
      <vt:lpstr>מצגת של PowerPoint</vt:lpstr>
      <vt:lpstr>מצגת של PowerPoint</vt:lpstr>
      <vt:lpstr>מצגת של PowerPoint</vt:lpstr>
      <vt:lpstr>מצגת של PowerPoint</vt:lpstr>
      <vt:lpstr>מצגת של PowerPoint</vt:lpstr>
      <vt:lpstr>מצגת של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</dc:title>
  <dc:creator>polak</dc:creator>
  <cp:lastModifiedBy>polak</cp:lastModifiedBy>
  <cp:revision>12</cp:revision>
  <dcterms:created xsi:type="dcterms:W3CDTF">2021-09-23T16:48:29Z</dcterms:created>
  <dcterms:modified xsi:type="dcterms:W3CDTF">2022-03-05T19:53:55Z</dcterms:modified>
</cp:coreProperties>
</file>